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83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B1F1C40-594F-473F-A848-EB5EB85F1D7A}" v="11" dt="2022-09-15T05:49:47.622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3394" autoAdjust="0"/>
    <p:restoredTop sz="94660"/>
  </p:normalViewPr>
  <p:slideViewPr>
    <p:cSldViewPr snapToGrid="0" showGuides="1">
      <p:cViewPr varScale="1">
        <p:scale>
          <a:sx n="111" d="100"/>
          <a:sy n="111" d="100"/>
        </p:scale>
        <p:origin x="108" y="114"/>
      </p:cViewPr>
      <p:guideLst>
        <p:guide orient="horz" pos="2183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E2555CF-DC6F-5423-7F75-E3A4844D517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F08B8CD2-F0A4-10DC-6B74-DDC4834B94A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AA777FA-FCD3-B7A5-9D38-7BC8975065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C8303-2C78-46CD-942E-35A8FE79346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1D83AE4-D08C-DECA-1A89-296ADC69C4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67C0677-078D-4FCA-4884-BB0BD69C80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EAD44-7E70-4B24-9CB8-423D9ED298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834670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F8780DA-4C32-0884-F8A4-8E716EAA69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E5EB0FDB-3EF3-0C12-4722-E041EB684F1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A7CAE33-A77C-C6D8-B730-B21B7B0453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C8303-2C78-46CD-942E-35A8FE79346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6747B21-632F-AF69-3187-D915138434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46DEE93-2239-3BD8-002D-883185441A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EAD44-7E70-4B24-9CB8-423D9ED298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099625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EE217E4C-EED0-2943-C890-74959303F0F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7356382F-77A3-6824-0474-3A6E34A4649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EB80BED-F248-9573-B9D8-D4D35B8F8A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C8303-2C78-46CD-942E-35A8FE79346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E20D56D-473A-E8CE-021E-F207CBBC00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94F7342-E49D-9417-7C2D-AD5C31F919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EAD44-7E70-4B24-9CB8-423D9ED298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206163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92142D4-F5B9-FA2E-C7F5-4B73D433CA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AAB3C325-F715-782A-F21B-689BF55B724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7D00699-787C-2BE5-A354-9D36EBB906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C8303-2C78-46CD-942E-35A8FE79346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C247A82-0F7A-0D8C-274E-CDC1259563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5C11F8A-2687-EDAC-49B5-002938C537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EAD44-7E70-4B24-9CB8-423D9ED298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571111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2DD99EF-2BB3-BA25-616B-7F1BAE5418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A50C4671-2C2E-6665-FA29-2872D7876E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FBBA4C5-EEF1-20F6-5320-1C19B51913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C8303-2C78-46CD-942E-35A8FE79346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B490E48-81F0-8DB0-935B-2927BD4001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35A261C-248B-68FD-70C9-6398C344C9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EAD44-7E70-4B24-9CB8-423D9ED298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983180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C3848AA-5135-F12C-90E1-24A4854C2F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67F3090A-5800-9C20-5AE3-FEF1B2DFA5A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C003CEAB-2744-1504-1542-51195CA724A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C286097A-5792-4588-9D10-29390FD02E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C8303-2C78-46CD-942E-35A8FE79346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A45113BA-4D85-1CB8-FCDC-0487F8CD75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ECF779B3-241D-C8FF-F601-41C982916E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EAD44-7E70-4B24-9CB8-423D9ED298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650216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F2A08D0-30D7-9736-963D-305B5332DD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654959A5-92FA-0294-1CBE-E9588AC14C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41EB57E6-B0E1-9361-FB05-72AC4A4908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547E0C99-FBBE-0D39-93C2-B5BADB7C676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14A9E7EB-70B6-FCB1-2BC5-3C8FB08754C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53A5DD06-2449-8875-3F18-06A8196EA4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C8303-2C78-46CD-942E-35A8FE79346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64545EFC-DE42-8778-CAF8-BBE2131AAE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4C397A84-CF1E-D51A-D01B-5ED85E2A03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EAD44-7E70-4B24-9CB8-423D9ED298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436850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672CB51-D92B-3E84-1F0F-3A6174F1AF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9339238A-C6D7-77C6-81BD-095C0FBB60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C8303-2C78-46CD-942E-35A8FE79346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A568916B-29E5-6BCE-0814-7C7B227786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E99B240E-840E-7BE7-4D8F-C27AB14BEF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EAD44-7E70-4B24-9CB8-423D9ED298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592872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B0BBE02F-4050-54DE-58DC-AD87ABDB99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C8303-2C78-46CD-942E-35A8FE79346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8E3660C4-8C76-3B86-B3B3-642C342BE0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0DA76F8E-E36E-F611-06BF-C854191E85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EAD44-7E70-4B24-9CB8-423D9ED298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17643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A8E7107-B5D7-FCC9-2DB8-4E271AB3F8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0EEC8623-278D-A43C-6210-451136B714E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EF649A39-47C1-02A8-CB14-372ACFF48FD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2219D26C-FFDD-D140-4B78-1210BD9658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C8303-2C78-46CD-942E-35A8FE79346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974DAA3C-B2CF-1051-7EA8-A7A7A4ACAC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5C0FC3AF-D08B-908B-13A0-5AFDFFE839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EAD44-7E70-4B24-9CB8-423D9ED298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390752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154FCD5-39CD-5C1B-A900-05DAA85738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59CC5B44-3B46-64B6-1027-7CF6767AA0E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B471B25D-1E5C-2706-32B8-2E33A99E413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8F340746-492F-A98B-837E-8C5A645E75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C8303-2C78-46CD-942E-35A8FE79346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52494E25-1EFA-C2D6-E45F-07F55DD6BC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77B390A7-459B-A087-D1F2-8CA54BC4F2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EAD44-7E70-4B24-9CB8-423D9ED298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734025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735686A0-9E5A-873C-B13F-110DDF8079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6706AFC2-048B-30A8-7CF8-EA3BA83B9A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E157270-A9BA-BEC2-1CC2-7B3226BD367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3C8303-2C78-46CD-942E-35A8FE79346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D051C9C-BD6E-9B46-22ED-7DF35F64FB6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671A535-6FFF-B9B9-4DAE-2D0C6A545B8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2EAD44-7E70-4B24-9CB8-423D9ED298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666062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6CD6810D-BD46-A984-6ACF-DF08BB20C6C8}"/>
              </a:ext>
            </a:extLst>
          </p:cNvPr>
          <p:cNvSpPr txBox="1"/>
          <p:nvPr/>
        </p:nvSpPr>
        <p:spPr>
          <a:xfrm>
            <a:off x="1078301" y="1406106"/>
            <a:ext cx="883151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 fontAlgn="ctr"/>
            <a:r>
              <a:rPr lang="en-US" altLang="ko-KR" sz="14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S1 Table. Primers used in </a:t>
            </a:r>
            <a:r>
              <a:rPr lang="en-US" altLang="ko-KR" sz="1400" b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qRT</a:t>
            </a:r>
            <a:r>
              <a:rPr lang="en-US" altLang="ko-KR" sz="14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-PCR for validation of RNA-sequencing.</a:t>
            </a:r>
            <a:endParaRPr lang="en-US" altLang="ko-KR" sz="1050" b="1" i="0" u="none" strike="noStrike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맑은 고딕" panose="020B0503020000020004" pitchFamily="34" charset="-127"/>
            </a:endParaRPr>
          </a:p>
        </p:txBody>
      </p:sp>
      <p:graphicFrame>
        <p:nvGraphicFramePr>
          <p:cNvPr id="2" name="표 1">
            <a:extLst>
              <a:ext uri="{FF2B5EF4-FFF2-40B4-BE49-F238E27FC236}">
                <a16:creationId xmlns:a16="http://schemas.microsoft.com/office/drawing/2014/main" id="{79C84E05-8C65-8C19-22AC-1C630BFB7F3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6770663"/>
              </p:ext>
            </p:extLst>
          </p:nvPr>
        </p:nvGraphicFramePr>
        <p:xfrm>
          <a:off x="1193800" y="1804987"/>
          <a:ext cx="9804400" cy="3248025"/>
        </p:xfrm>
        <a:graphic>
          <a:graphicData uri="http://schemas.openxmlformats.org/drawingml/2006/table">
            <a:tbl>
              <a:tblPr/>
              <a:tblGrid>
                <a:gridCol w="637968">
                  <a:extLst>
                    <a:ext uri="{9D8B030D-6E8A-4147-A177-3AD203B41FA5}">
                      <a16:colId xmlns:a16="http://schemas.microsoft.com/office/drawing/2014/main" val="3108940140"/>
                    </a:ext>
                  </a:extLst>
                </a:gridCol>
                <a:gridCol w="3440586">
                  <a:extLst>
                    <a:ext uri="{9D8B030D-6E8A-4147-A177-3AD203B41FA5}">
                      <a16:colId xmlns:a16="http://schemas.microsoft.com/office/drawing/2014/main" val="178023191"/>
                    </a:ext>
                  </a:extLst>
                </a:gridCol>
                <a:gridCol w="3427890">
                  <a:extLst>
                    <a:ext uri="{9D8B030D-6E8A-4147-A177-3AD203B41FA5}">
                      <a16:colId xmlns:a16="http://schemas.microsoft.com/office/drawing/2014/main" val="1740729126"/>
                    </a:ext>
                  </a:extLst>
                </a:gridCol>
                <a:gridCol w="1142630">
                  <a:extLst>
                    <a:ext uri="{9D8B030D-6E8A-4147-A177-3AD203B41FA5}">
                      <a16:colId xmlns:a16="http://schemas.microsoft.com/office/drawing/2014/main" val="2117316798"/>
                    </a:ext>
                  </a:extLst>
                </a:gridCol>
                <a:gridCol w="1155326">
                  <a:extLst>
                    <a:ext uri="{9D8B030D-6E8A-4147-A177-3AD203B41FA5}">
                      <a16:colId xmlns:a16="http://schemas.microsoft.com/office/drawing/2014/main" val="3204339739"/>
                    </a:ext>
                  </a:extLst>
                </a:gridCol>
              </a:tblGrid>
              <a:tr h="228600"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Primer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Sequence (5’ - 3'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Target size</a:t>
                      </a:r>
                    </a:p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(bp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Target contig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98498386"/>
                  </a:ext>
                </a:extLst>
              </a:tr>
              <a:tr h="22860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Forward primer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Revers primer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92175996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B1.2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34" charset="-127"/>
                          <a:cs typeface="Courier New" panose="02070309020205020404" pitchFamily="49" charset="0"/>
                        </a:rPr>
                        <a:t>TCAATCGTCACGCGCTACAT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(Tm: 60.2 GC:50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34" charset="-127"/>
                          <a:cs typeface="Courier New" panose="02070309020205020404" pitchFamily="49" charset="0"/>
                        </a:rPr>
                        <a:t>TCGTCACTCTGAGAGGTGGA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(Tm: 59.6 GC:55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10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YJR078W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6681228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B2.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34" charset="-127"/>
                          <a:cs typeface="Courier New" panose="02070309020205020404" pitchFamily="49" charset="0"/>
                        </a:rPr>
                        <a:t>ATGATGCGTGCCTTGCTATG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(Tm: 59.1 GC:50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34" charset="-127"/>
                          <a:cs typeface="Courier New" panose="02070309020205020404" pitchFamily="49" charset="0"/>
                        </a:rPr>
                        <a:t>CGACAGCGATGTTATTGCGG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(Tm: 60.0 GC:55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14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YJR078W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95143599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B3.2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34" charset="-127"/>
                          <a:cs typeface="Courier New" panose="02070309020205020404" pitchFamily="49" charset="0"/>
                        </a:rPr>
                        <a:t>CATCTCCGGCATCTACGACC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(Tm: 60.0 GC:60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34" charset="-127"/>
                          <a:cs typeface="Courier New" panose="02070309020205020404" pitchFamily="49" charset="0"/>
                        </a:rPr>
                        <a:t>CTGGAGAAGCCTGCATCCAA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(Tm: 60.0 GC:55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11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YDR428C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9236452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B3.2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34" charset="-127"/>
                          <a:cs typeface="Courier New" panose="02070309020205020404" pitchFamily="49" charset="0"/>
                        </a:rPr>
                        <a:t>ATGGCCGAGAAGCTTAGAGC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(Tm: 59.9 GC:55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34" charset="-127"/>
                          <a:cs typeface="Courier New" panose="02070309020205020404" pitchFamily="49" charset="0"/>
                        </a:rPr>
                        <a:t>ACGGTTCACAAGAGTGGCAA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(Tm: 60.1 GC:50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11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YDR428C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72276267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B4.2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34" charset="-127"/>
                          <a:cs typeface="Courier New" panose="02070309020205020404" pitchFamily="49" charset="0"/>
                        </a:rPr>
                        <a:t>TTGGGACAGAGATTCAGCCG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(Tm: 59.8 GC:55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34" charset="-127"/>
                          <a:cs typeface="Courier New" panose="02070309020205020404" pitchFamily="49" charset="0"/>
                        </a:rPr>
                        <a:t>ATAGCCATGCAAGCTCCCTG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(Tm: 60.2 GC:55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13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YBL098W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00866511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B5.2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34" charset="-127"/>
                          <a:cs typeface="Courier New" panose="02070309020205020404" pitchFamily="49" charset="0"/>
                        </a:rPr>
                        <a:t>ATGAAGGACCTGCGCTCAAA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(Tm: 60.0 GC:50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34" charset="-127"/>
                          <a:cs typeface="Courier New" panose="02070309020205020404" pitchFamily="49" charset="0"/>
                        </a:rPr>
                        <a:t>CGGGGTCAATACGCGGAATA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(Tm: 60.0 GC:55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12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YLR231C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9181935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B6.2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34" charset="-127"/>
                          <a:cs typeface="Courier New" panose="02070309020205020404" pitchFamily="49" charset="0"/>
                        </a:rPr>
                        <a:t>CCGCACAGACTACCACATCA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(Tm: 59.8 GC:55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34" charset="-127"/>
                          <a:cs typeface="Courier New" panose="02070309020205020404" pitchFamily="49" charset="0"/>
                        </a:rPr>
                        <a:t>GCGGATGAAAATGTCGCGAA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(Tm: 59.9 GC:50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11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YJR025C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26671378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RM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34" charset="-127"/>
                          <a:cs typeface="Courier New" panose="02070309020205020404" pitchFamily="49" charset="0"/>
                        </a:rPr>
                        <a:t>CGCTCCATCATGACCTACCT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(Tm: 60.1 GC:55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34" charset="-127"/>
                          <a:cs typeface="Courier New" panose="02070309020205020404" pitchFamily="49" charset="0"/>
                        </a:rPr>
                        <a:t>CGCCTCAAACTGGACCATAC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(Tm: 60.5 GC:55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13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Trinity_i103_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84327574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RM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34" charset="-127"/>
                          <a:cs typeface="Courier New" panose="02070309020205020404" pitchFamily="49" charset="0"/>
                        </a:rPr>
                        <a:t>CGCTCCATCATGACCTACCT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(Tm: 60.1 GC:55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34" charset="-127"/>
                          <a:cs typeface="Courier New" panose="02070309020205020404" pitchFamily="49" charset="0"/>
                        </a:rPr>
                        <a:t>CCTCAAACTGGACCATACGC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(Tm: 60.5 GC:55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13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Trinity_i103_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98335154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RM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34" charset="-127"/>
                          <a:cs typeface="Courier New" panose="02070309020205020404" pitchFamily="49" charset="0"/>
                        </a:rPr>
                        <a:t>CAACAACGCGAGAGTGTTCT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(Tm: 59.1 GC:50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34" charset="-127"/>
                          <a:cs typeface="Courier New" panose="02070309020205020404" pitchFamily="49" charset="0"/>
                        </a:rPr>
                        <a:t>GCGTATCCGCCTTGGTTAT 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(Tm: 59.9 GC:52.6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13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Trinity_i1901_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42828810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RM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34" charset="-127"/>
                          <a:cs typeface="Courier New" panose="02070309020205020404" pitchFamily="49" charset="0"/>
                        </a:rPr>
                        <a:t>TTCTCCGACAAGCAGTCGTT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(Tm: 61.0 GC:50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34" charset="-127"/>
                          <a:cs typeface="Courier New" panose="02070309020205020404" pitchFamily="49" charset="0"/>
                        </a:rPr>
                        <a:t>GCGTATCCGCCTTGGTTAT 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(Tm: 59.9 GC:52.6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11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Trinity_i1901_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0462791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RM3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34" charset="-127"/>
                          <a:cs typeface="Courier New" panose="02070309020205020404" pitchFamily="49" charset="0"/>
                        </a:rPr>
                        <a:t>CCTTGTCCAGGACTTTTTCG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(Tm: 59.7 GC:50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34" charset="-127"/>
                          <a:cs typeface="Courier New" panose="02070309020205020404" pitchFamily="49" charset="0"/>
                        </a:rPr>
                        <a:t>ACGATCTGCACGACGGTTAG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(Tm: 61.3 GC:55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1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Trinity_i403_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5043357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824265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4</TotalTime>
  <Words>293</Words>
  <Application>Microsoft Office PowerPoint</Application>
  <PresentationFormat>와이드스크린</PresentationFormat>
  <Paragraphs>68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ourier New</vt:lpstr>
      <vt:lpstr>Times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박소은</dc:creator>
  <cp:lastModifiedBy>김재수</cp:lastModifiedBy>
  <cp:revision>4</cp:revision>
  <dcterms:created xsi:type="dcterms:W3CDTF">2022-09-13T05:05:03Z</dcterms:created>
  <dcterms:modified xsi:type="dcterms:W3CDTF">2023-01-06T05:04:47Z</dcterms:modified>
</cp:coreProperties>
</file>